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2CC684-FD82-47B4-A041-99E8BB7863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35A32-AF5A-4BCC-9C09-9663A8A1D8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CD6AD-DFA7-4618-9975-9E1339A9E1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91BE4-F880-48C0-8AF9-AD69C7034B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A61828-8714-4EFC-AF14-804E97CFB6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7F42C-824D-4FB9-8989-1BEDEA23CA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40D03-8BD0-4068-8C34-5B13E77CEB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B07A7-8FE8-42A3-80A8-ABA242F488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604448-6C09-48C1-A602-B9148DFC52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D4433B-FE32-4969-9AD7-C90AAA712C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B18155-36C8-494C-BE71-F07FE78A3B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1391E-73E1-482D-A88F-E999D18980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9932E1-AC0E-4E59-A44C-371EAD150F18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2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2.png"/><Relationship Id="rId8" Type="http://schemas.openxmlformats.org/officeDocument/2006/relationships/image" Target="../media/image2.png"/><Relationship Id="rId9" Type="http://schemas.openxmlformats.org/officeDocument/2006/relationships/image" Target="../media/image2.png"/><Relationship Id="rId10" Type="http://schemas.openxmlformats.org/officeDocument/2006/relationships/image" Target="../media/image3.wmf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6071" t="4964" r="9648" b="23178"/>
          <a:stretch/>
        </p:blipFill>
        <p:spPr>
          <a:xfrm>
            <a:off x="933480" y="7442280"/>
            <a:ext cx="3444840" cy="13716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66600" y="66600"/>
            <a:ext cx="171468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ato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 al.,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igure 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703440" y="71596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11360" y="7184880"/>
            <a:ext cx="5400360" cy="17877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2338560" y="8263080"/>
            <a:ext cx="91800" cy="9180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2509920" y="7966080"/>
            <a:ext cx="92160" cy="9216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4"/>
          <a:stretch/>
        </p:blipFill>
        <p:spPr>
          <a:xfrm>
            <a:off x="3544920" y="8325000"/>
            <a:ext cx="92160" cy="9180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5"/>
          <a:stretch/>
        </p:blipFill>
        <p:spPr>
          <a:xfrm>
            <a:off x="3376440" y="8308800"/>
            <a:ext cx="92160" cy="9216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6"/>
          <a:stretch/>
        </p:blipFill>
        <p:spPr>
          <a:xfrm>
            <a:off x="3201840" y="8234280"/>
            <a:ext cx="92160" cy="9216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7"/>
          <a:stretch/>
        </p:blipFill>
        <p:spPr>
          <a:xfrm>
            <a:off x="3032280" y="8150400"/>
            <a:ext cx="91800" cy="9180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8"/>
          <a:stretch/>
        </p:blipFill>
        <p:spPr>
          <a:xfrm>
            <a:off x="3719520" y="8318520"/>
            <a:ext cx="92160" cy="9216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9"/>
          <a:stretch/>
        </p:blipFill>
        <p:spPr>
          <a:xfrm>
            <a:off x="2681280" y="8304120"/>
            <a:ext cx="92160" cy="9216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4340160" y="7257960"/>
            <a:ext cx="666720" cy="486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711360" y="487440"/>
            <a:ext cx="5400360" cy="66006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08120" y="484200"/>
            <a:ext cx="34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129600" y="8074800"/>
            <a:ext cx="1489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Trans. Level (Log10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124160" y="7267680"/>
            <a:ext cx="870120" cy="6127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044000" y="865512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217160" y="865512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385640" y="865512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557000" y="865656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733040" y="8656560"/>
            <a:ext cx="238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87560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04696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21832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38500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55672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73276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90412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07584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24720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41856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58992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76632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937680" y="865512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106160" y="8656560"/>
            <a:ext cx="296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321080" y="7191360"/>
            <a:ext cx="897120" cy="176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-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-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PA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-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P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-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4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- 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3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OM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1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OMT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4C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H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6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C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156280" y="7191360"/>
            <a:ext cx="1092240" cy="14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9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REF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CH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F3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6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F3’H-lik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7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F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8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ANS-lik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9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3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3G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1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lR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735440" y="1994040"/>
            <a:ext cx="218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#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"/>
          <p:cNvGrpSpPr/>
          <p:nvPr/>
        </p:nvGrpSpPr>
        <p:grpSpPr>
          <a:xfrm>
            <a:off x="3849840" y="7286760"/>
            <a:ext cx="469800" cy="449280"/>
            <a:chOff x="3849840" y="7286760"/>
            <a:chExt cx="469800" cy="449280"/>
          </a:xfrm>
        </p:grpSpPr>
        <p:sp>
          <p:nvSpPr>
            <p:cNvPr id="81" name=""/>
            <p:cNvSpPr/>
            <p:nvPr/>
          </p:nvSpPr>
          <p:spPr>
            <a:xfrm>
              <a:off x="3849840" y="7286760"/>
              <a:ext cx="469800" cy="44928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895560" y="7356600"/>
              <a:ext cx="84240" cy="92160"/>
            </a:xfrm>
            <a:prstGeom prst="rect">
              <a:avLst/>
            </a:prstGeom>
            <a:solidFill>
              <a:srgbClr val="80808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039200" y="7329600"/>
              <a:ext cx="236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895560" y="7567560"/>
              <a:ext cx="84240" cy="907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081680" y="7539120"/>
              <a:ext cx="67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y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86" name="" descr=""/>
          <p:cNvPicPr/>
          <p:nvPr/>
        </p:nvPicPr>
        <p:blipFill>
          <a:blip r:embed="rId10"/>
          <a:stretch/>
        </p:blipFill>
        <p:spPr>
          <a:xfrm>
            <a:off x="758880" y="515880"/>
            <a:ext cx="5324400" cy="6597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4T02:28:35Z</dcterms:created>
  <dc:creator>WinXP</dc:creator>
  <dc:description/>
  <dc:language>en-US</dc:language>
  <cp:lastModifiedBy>WinXP</cp:lastModifiedBy>
  <dcterms:modified xsi:type="dcterms:W3CDTF">2009-10-24T03:45:03Z</dcterms:modified>
  <cp:revision>7</cp:revision>
  <dc:subject/>
  <dc:title>Slide 1</dc:title>
</cp:coreProperties>
</file>